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F9CAB0A-D2E1-4A18-97D9-DBCB53DCDFA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C4BA2DF-74EE-4D17-9749-C4620044FA3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62FAAAA-3D1F-4E81-AAF4-1F814E18E86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E1EBA4C-8BBD-41ED-A337-EEC0167C23A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2372EE6-E356-48A3-952A-51DF37BA4A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98A2410-349D-413F-A7B4-9F9BB9A843B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2A278D-C97D-45AD-AFF2-FBDB33981A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19E5FDE-4E3E-4794-A032-8E3ED45A540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D417178-DF38-420A-8FEC-6B81B29D3C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24FCF45-4E64-4360-9A26-D2F444E1A0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57FE5AD-70CF-4761-B876-8E143E6D80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14EBFB6-D4BB-4BBB-9AD4-D0E159EFA2E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DFC07E0-763E-460C-A100-385FB33D770F}" type="datetime">
              <a:rPr b="0" lang="en-US" sz="1200" spc="-1" strike="noStrike">
                <a:solidFill>
                  <a:srgbClr val="898989"/>
                </a:solidFill>
                <a:latin typeface="Calibri"/>
              </a:rPr>
              <a:t>08/29/26</a:t>
            </a:fld>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37D6CC0-AD10-4A1F-9602-F17332740438}"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119160" y="1303200"/>
          <a:ext cx="6426000" cy="2719440"/>
        </p:xfrm>
        <a:graphic>
          <a:graphicData uri="http://schemas.openxmlformats.org/drawingml/2006/table">
            <a:tbl>
              <a:tblPr/>
              <a:tblGrid>
                <a:gridCol w="2033640"/>
                <a:gridCol w="547560"/>
                <a:gridCol w="547560"/>
                <a:gridCol w="547920"/>
                <a:gridCol w="617400"/>
                <a:gridCol w="480960"/>
                <a:gridCol w="549360"/>
                <a:gridCol w="550800"/>
                <a:gridCol w="550800"/>
              </a:tblGrid>
              <a:tr h="435240">
                <a:tc>
                  <a:txBody>
                    <a:bodyPr lIns="9000" rIns="9000" tIns="9000" bIns="0" anchor="b">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a:txBody>
                  <a:tcPr anchor="b" marL="9000" marR="9000">
                    <a:lnL>
                      <a:noFill/>
                    </a:lnL>
                    <a:lnR>
                      <a:noFill/>
                    </a:lnR>
                    <a:lnT w="5760">
                      <a:solidFill>
                        <a:srgbClr val="000000"/>
                      </a:solidFill>
                    </a:lnT>
                    <a:lnB w="5760">
                      <a:solidFill>
                        <a:srgbClr val="000000"/>
                      </a:solidFill>
                    </a:lnB>
                    <a:noFill/>
                  </a:tcPr>
                </a:tc>
                <a:tc gridSpan="4">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Arial"/>
                          <a:ea typeface="Arial"/>
                        </a:rPr>
                        <a:t>Dendrite phenotype of ablated animals (n)</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4">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Arial"/>
                          <a:ea typeface="Arial"/>
                        </a:rPr>
                        <a:t>Dendrite phenotype of mock-ablated controls (n)</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326880">
                <a:tc>
                  <a:txBody>
                    <a:bodyPr lIns="9000" rIns="9000" tIns="9000" bIns="0" anchor="b">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900" spc="-1" strike="noStrike">
                          <a:solidFill>
                            <a:srgbClr val="000000"/>
                          </a:solidFill>
                          <a:latin typeface="Arial"/>
                          <a:ea typeface="Arial"/>
                        </a:rPr>
                        <a:t>Cells ablated</a:t>
                      </a:r>
                      <a:endParaRPr b="0" lang="en-US" sz="900" spc="-1" strike="noStrike">
                        <a:solidFill>
                          <a:srgbClr val="000000"/>
                        </a:solidFill>
                        <a:latin typeface="Calibri"/>
                      </a:endParaRPr>
                    </a:p>
                  </a:txBody>
                  <a:tcPr anchor="b"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Total n</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Normal</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Short</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Branched</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Total n</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Normal</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Short</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Branched</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688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Left phasmid socket cells</a:t>
                      </a:r>
                      <a:endParaRPr b="0" lang="en-US" sz="9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PHso1L, PHso2L)   </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544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Left phasmid sheath cell</a:t>
                      </a:r>
                      <a:endParaRPr b="0" lang="en-US" sz="9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PHshL)</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25</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24</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3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3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724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Left phasmid socket and sheath cells (PHso1L, PHso2L, PHshL)</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9</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5</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5</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5</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544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Left and right phasmid socket cells (PHso1L, PHso2L, PHso1R, PHso2R)</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5</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1</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3</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688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Left phasmid neurons (PHAL,PHBL)</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2</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8</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r h="325440">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ALN neuron</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4</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4</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3</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13</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c>
                  <a:txBody>
                    <a:bodyPr lIns="9000" rIns="9000" tIns="9000" bIns="0" anchor="ctr">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0</a:t>
                      </a:r>
                      <a:endParaRPr b="0" lang="en-US" sz="900" spc="-1" strike="noStrike">
                        <a:solidFill>
                          <a:srgbClr val="000000"/>
                        </a:solidFill>
                        <a:latin typeface="Calibri"/>
                      </a:endParaRPr>
                    </a:p>
                  </a:txBody>
                  <a:tcPr anchor="ctr" marL="9000" marR="9000">
                    <a:lnL>
                      <a:noFill/>
                    </a:lnL>
                    <a:lnR>
                      <a:noFill/>
                    </a:lnR>
                    <a:lnT w="5760">
                      <a:solidFill>
                        <a:srgbClr val="000000"/>
                      </a:solidFill>
                    </a:lnT>
                    <a:lnB w="5760">
                      <a:solidFill>
                        <a:srgbClr val="000000"/>
                      </a:solidFill>
                    </a:lnB>
                    <a:noFill/>
                  </a:tcPr>
                </a:tc>
              </a:tr>
            </a:tbl>
          </a:graphicData>
        </a:graphic>
      </p:graphicFrame>
      <p:sp>
        <p:nvSpPr>
          <p:cNvPr id="42" name="Rectangle 4"/>
          <p:cNvSpPr/>
          <p:nvPr/>
        </p:nvSpPr>
        <p:spPr>
          <a:xfrm>
            <a:off x="119160" y="806400"/>
            <a:ext cx="6294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ea typeface="Arial"/>
              </a:rPr>
              <a:t>Table S2.  Dendrite phenotypes in cell-ablation experiments</a:t>
            </a:r>
            <a:r>
              <a:rPr b="1" lang="en-US" sz="1200" spc="-1" strike="noStrike">
                <a:solidFill>
                  <a:srgbClr val="000000"/>
                </a:solidFill>
                <a:latin typeface="Arial"/>
                <a:ea typeface="Arial"/>
              </a:rPr>
              <a:t>. </a:t>
            </a:r>
            <a:endParaRPr b="0" lang="en-US" sz="1200" spc="-1" strike="noStrike">
              <a:solidFill>
                <a:srgbClr val="000000"/>
              </a:solidFill>
              <a:latin typeface="Calibri"/>
            </a:endParaRPr>
          </a:p>
        </p:txBody>
      </p:sp>
      <p:sp>
        <p:nvSpPr>
          <p:cNvPr id="43" name="TextBox 5"/>
          <p:cNvSpPr/>
          <p:nvPr/>
        </p:nvSpPr>
        <p:spPr>
          <a:xfrm>
            <a:off x="119160" y="4170240"/>
            <a:ext cx="6576840" cy="1054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ea typeface="Arial"/>
              </a:rPr>
              <a:t>Ablations were performed in </a:t>
            </a:r>
            <a:r>
              <a:rPr b="0" i="1" lang="en-US" sz="900" spc="-1" strike="noStrike">
                <a:solidFill>
                  <a:srgbClr val="000000"/>
                </a:solidFill>
                <a:latin typeface="Arial"/>
                <a:ea typeface="Arial"/>
              </a:rPr>
              <a:t>kyIs417 </a:t>
            </a:r>
            <a:r>
              <a:rPr b="0" lang="en-US" sz="900" spc="-1" strike="noStrike">
                <a:solidFill>
                  <a:srgbClr val="000000"/>
                </a:solidFill>
                <a:latin typeface="Arial"/>
                <a:ea typeface="Arial"/>
              </a:rPr>
              <a:t>(wild-type) larvae within 1hr of hatching and animals were scored at the L4 stage.  Short dendrites were observed in animals that had combined ablation of left phasmid socket and sheath cells (third row, PHso1L, PHso2L, PHshL), or left and right phasmid sheath cells, (fourth row, PHso1L, PHso2L, PHso1R, PHso2R).  Branched dendrites were also observed (“branched” refers to long branches from the dendrite that are not normally seen in the wild-type strain).  Dendrites were scored as “normal” when they appeared as in the wild-type strain, </a:t>
            </a:r>
            <a:r>
              <a:rPr b="0" i="1" lang="en-US" sz="900" spc="-1" strike="noStrike">
                <a:solidFill>
                  <a:srgbClr val="000000"/>
                </a:solidFill>
                <a:latin typeface="Arial"/>
                <a:ea typeface="Arial"/>
              </a:rPr>
              <a:t>kyIs417</a:t>
            </a:r>
            <a:r>
              <a:rPr b="0" lang="en-US" sz="900" spc="-1" strike="noStrike">
                <a:solidFill>
                  <a:srgbClr val="000000"/>
                </a:solidFill>
                <a:latin typeface="Arial"/>
                <a:ea typeface="Arial"/>
              </a:rPr>
              <a:t>; these included PQR neurons with very small dendrite branches, or a small ectopic process extending posterior.  </a:t>
            </a:r>
            <a:endParaRPr b="0" lang="en-US" sz="9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9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2-09T00:25:38Z</dcterms:created>
  <dc:creator>Leonie Kirszenblat</dc:creator>
  <dc:description/>
  <dc:language>en-US</dc:language>
  <cp:lastModifiedBy>Massimo Hilliard - Mobile</cp:lastModifiedBy>
  <dcterms:modified xsi:type="dcterms:W3CDTF">2011-02-09T07:03:46Z</dcterms:modified>
  <cp:revision>28</cp:revision>
  <dc:subject/>
  <dc:title>Slide 1</dc:title>
</cp:coreProperties>
</file>